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1388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43608" y="548680"/>
            <a:ext cx="76431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effectLst/>
                <a:latin typeface="+mj-lt"/>
                <a:ea typeface="宋体" panose="02010600030101010101" pitchFamily="2" charset="-122"/>
                <a:cs typeface="Times New Roman" panose="02020603050405020304" pitchFamily="18" charset="0"/>
              </a:rPr>
              <a:t>GO enrichment of down-regulated DEGs at adenoma stage</a:t>
            </a:r>
            <a:endParaRPr lang="zh-CN" altLang="en-US" sz="2400" dirty="0"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D35FB2E-6F4E-4916-AB13-CD5A088D7B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680" y="1700808"/>
            <a:ext cx="5760640" cy="4561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5705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zh-CN" sz="24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GO enrichment of down-regulated DEGs at </a:t>
            </a:r>
            <a:r>
              <a:rPr lang="en-US" altLang="zh-CN" sz="2400" dirty="0">
                <a:effectLst/>
                <a:ea typeface="宋体" panose="02010600030101010101" pitchFamily="2" charset="-122"/>
              </a:rPr>
              <a:t>late adenocarcinoma stage</a:t>
            </a:r>
            <a:endParaRPr lang="zh-CN" altLang="en-US" sz="2400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079F90A-ADCC-40A2-835F-F7BD75F3BD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3668" y="1628800"/>
            <a:ext cx="5976664" cy="4725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78596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24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GO enrichment of down-regulated DEGs at </a:t>
            </a:r>
            <a:r>
              <a:rPr lang="en-US" altLang="zh-CN" sz="2400" dirty="0">
                <a:effectLst/>
                <a:ea typeface="宋体" panose="02010600030101010101" pitchFamily="2" charset="-122"/>
              </a:rPr>
              <a:t>lung metastasis stage</a:t>
            </a:r>
            <a:endParaRPr lang="zh-CN" altLang="en-US" sz="2400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8E8276C-F419-42AD-8B4A-B5125188C8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640" y="1556792"/>
            <a:ext cx="6480720" cy="5164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2279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全屏显示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主题</vt:lpstr>
      <vt:lpstr>PowerPoint 演示文稿</vt:lpstr>
      <vt:lpstr>GO enrichment of down-regulated DEGs at late adenocarcinoma stage</vt:lpstr>
      <vt:lpstr>GO enrichment of down-regulated DEGs at lung metastasis stag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gccc003@hotmail.com</cp:lastModifiedBy>
  <cp:revision>2</cp:revision>
  <dcterms:created xsi:type="dcterms:W3CDTF">2018-08-14T15:11:47Z</dcterms:created>
  <dcterms:modified xsi:type="dcterms:W3CDTF">2021-01-27T23:25:59Z</dcterms:modified>
</cp:coreProperties>
</file>